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2" d="100"/>
          <a:sy n="92" d="100"/>
        </p:scale>
        <p:origin x="109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濱名 智世" userId="948b4f9a3fd53d73" providerId="LiveId" clId="{CAD4D672-975F-4E90-B08A-2D3A7509AFB0}"/>
    <pc:docChg chg="modSld">
      <pc:chgData name="濱名 智世" userId="948b4f9a3fd53d73" providerId="LiveId" clId="{CAD4D672-975F-4E90-B08A-2D3A7509AFB0}" dt="2022-11-07T07:12:39.592" v="7" actId="14100"/>
      <pc:docMkLst>
        <pc:docMk/>
      </pc:docMkLst>
      <pc:sldChg chg="modSp mod">
        <pc:chgData name="濱名 智世" userId="948b4f9a3fd53d73" providerId="LiveId" clId="{CAD4D672-975F-4E90-B08A-2D3A7509AFB0}" dt="2022-11-07T07:12:39.592" v="7" actId="14100"/>
        <pc:sldMkLst>
          <pc:docMk/>
          <pc:sldMk cId="1255696130" sldId="256"/>
        </pc:sldMkLst>
        <pc:spChg chg="mod">
          <ac:chgData name="濱名 智世" userId="948b4f9a3fd53d73" providerId="LiveId" clId="{CAD4D672-975F-4E90-B08A-2D3A7509AFB0}" dt="2022-11-07T07:12:03.817" v="1" actId="207"/>
          <ac:spMkLst>
            <pc:docMk/>
            <pc:sldMk cId="1255696130" sldId="256"/>
            <ac:spMk id="4" creationId="{CB2B7E34-024C-0832-A5AE-FE85635B613F}"/>
          </ac:spMkLst>
        </pc:spChg>
        <pc:spChg chg="mod">
          <ac:chgData name="濱名 智世" userId="948b4f9a3fd53d73" providerId="LiveId" clId="{CAD4D672-975F-4E90-B08A-2D3A7509AFB0}" dt="2022-11-07T07:12:08.184" v="3" actId="207"/>
          <ac:spMkLst>
            <pc:docMk/>
            <pc:sldMk cId="1255696130" sldId="256"/>
            <ac:spMk id="5" creationId="{D1D5746A-31D1-F543-C6BB-F435B55D6582}"/>
          </ac:spMkLst>
        </pc:spChg>
        <pc:spChg chg="mod">
          <ac:chgData name="濱名 智世" userId="948b4f9a3fd53d73" providerId="LiveId" clId="{CAD4D672-975F-4E90-B08A-2D3A7509AFB0}" dt="2022-11-07T07:12:39.592" v="7" actId="14100"/>
          <ac:spMkLst>
            <pc:docMk/>
            <pc:sldMk cId="1255696130" sldId="256"/>
            <ac:spMk id="12" creationId="{7B17A2E7-A4A3-D00D-78D3-11EFFBE8942C}"/>
          </ac:spMkLst>
        </pc:spChg>
        <pc:spChg chg="mod">
          <ac:chgData name="濱名 智世" userId="948b4f9a3fd53d73" providerId="LiveId" clId="{CAD4D672-975F-4E90-B08A-2D3A7509AFB0}" dt="2022-11-07T07:12:33.625" v="6" actId="14100"/>
          <ac:spMkLst>
            <pc:docMk/>
            <pc:sldMk cId="1255696130" sldId="256"/>
            <ac:spMk id="13" creationId="{7C6BDB9D-ED08-8ADA-9E0B-C173D3F6117D}"/>
          </ac:spMkLst>
        </pc:spChg>
      </pc:sldChg>
    </pc:docChg>
  </pc:docChgLst>
  <pc:docChgLst>
    <pc:chgData name="濱名 智世" userId="948b4f9a3fd53d73" providerId="LiveId" clId="{81F870BB-415A-4B5A-83CE-E7C51B440699}"/>
    <pc:docChg chg="undo custSel modSld">
      <pc:chgData name="濱名 智世" userId="948b4f9a3fd53d73" providerId="LiveId" clId="{81F870BB-415A-4B5A-83CE-E7C51B440699}" dt="2023-03-20T16:13:18.603" v="4" actId="207"/>
      <pc:docMkLst>
        <pc:docMk/>
      </pc:docMkLst>
      <pc:sldChg chg="modSp mod">
        <pc:chgData name="濱名 智世" userId="948b4f9a3fd53d73" providerId="LiveId" clId="{81F870BB-415A-4B5A-83CE-E7C51B440699}" dt="2023-03-20T16:13:18.603" v="4" actId="207"/>
        <pc:sldMkLst>
          <pc:docMk/>
          <pc:sldMk cId="1255696130" sldId="256"/>
        </pc:sldMkLst>
        <pc:spChg chg="mod">
          <ac:chgData name="濱名 智世" userId="948b4f9a3fd53d73" providerId="LiveId" clId="{81F870BB-415A-4B5A-83CE-E7C51B440699}" dt="2023-03-20T16:13:06.102" v="0" actId="207"/>
          <ac:spMkLst>
            <pc:docMk/>
            <pc:sldMk cId="1255696130" sldId="256"/>
            <ac:spMk id="4" creationId="{CB2B7E34-024C-0832-A5AE-FE85635B613F}"/>
          </ac:spMkLst>
        </pc:spChg>
        <pc:spChg chg="mod">
          <ac:chgData name="濱名 智世" userId="948b4f9a3fd53d73" providerId="LiveId" clId="{81F870BB-415A-4B5A-83CE-E7C51B440699}" dt="2023-03-20T16:13:18.603" v="4" actId="207"/>
          <ac:spMkLst>
            <pc:docMk/>
            <pc:sldMk cId="1255696130" sldId="256"/>
            <ac:spMk id="5" creationId="{D1D5746A-31D1-F543-C6BB-F435B55D6582}"/>
          </ac:spMkLst>
        </pc:spChg>
        <pc:spChg chg="mod">
          <ac:chgData name="濱名 智世" userId="948b4f9a3fd53d73" providerId="LiveId" clId="{81F870BB-415A-4B5A-83CE-E7C51B440699}" dt="2023-03-20T16:13:15.175" v="3" actId="207"/>
          <ac:spMkLst>
            <pc:docMk/>
            <pc:sldMk cId="1255696130" sldId="256"/>
            <ac:spMk id="13" creationId="{7C6BDB9D-ED08-8ADA-9E0B-C173D3F6117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443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7745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9068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186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042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948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470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3049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33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9288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8918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232E6D-F579-4EE1-A57B-F859D9A74B8F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390ECE-751E-44E3-8F05-9C86A457E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3899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CB2B7E34-024C-0832-A5AE-FE85635B613F}"/>
              </a:ext>
            </a:extLst>
          </p:cNvPr>
          <p:cNvSpPr/>
          <p:nvPr/>
        </p:nvSpPr>
        <p:spPr>
          <a:xfrm>
            <a:off x="523701" y="897774"/>
            <a:ext cx="6301048" cy="122197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bg1"/>
                </a:solidFill>
              </a:rPr>
              <a:t>60 patients underwent OFDI-guided PCI with RA</a:t>
            </a:r>
          </a:p>
          <a:p>
            <a:pPr algn="ctr"/>
            <a:r>
              <a:rPr kumimoji="1" lang="en-US" altLang="ja-JP" dirty="0">
                <a:solidFill>
                  <a:schemeClr val="bg1"/>
                </a:solidFill>
              </a:rPr>
              <a:t>(From April 2019 to August 2022)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D1D5746A-31D1-F543-C6BB-F435B55D6582}"/>
              </a:ext>
            </a:extLst>
          </p:cNvPr>
          <p:cNvSpPr/>
          <p:nvPr/>
        </p:nvSpPr>
        <p:spPr>
          <a:xfrm>
            <a:off x="523701" y="4857404"/>
            <a:ext cx="6301048" cy="969818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bg1"/>
                </a:solidFill>
              </a:rPr>
              <a:t>55 patients (474 cross-sections) were finally enrolled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D92B802C-35AC-5138-1A56-312E0A30B976}"/>
              </a:ext>
            </a:extLst>
          </p:cNvPr>
          <p:cNvCxnSpPr/>
          <p:nvPr/>
        </p:nvCxnSpPr>
        <p:spPr>
          <a:xfrm>
            <a:off x="3142211" y="2211187"/>
            <a:ext cx="0" cy="2485505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C3A0B864-7ABE-C213-CAC7-3BC2C6E90264}"/>
              </a:ext>
            </a:extLst>
          </p:cNvPr>
          <p:cNvCxnSpPr>
            <a:cxnSpLocks/>
          </p:cNvCxnSpPr>
          <p:nvPr/>
        </p:nvCxnSpPr>
        <p:spPr>
          <a:xfrm>
            <a:off x="3142211" y="3311237"/>
            <a:ext cx="980902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B17A2E7-A4A3-D00D-78D3-11EFFBE8942C}"/>
              </a:ext>
            </a:extLst>
          </p:cNvPr>
          <p:cNvSpPr txBox="1"/>
          <p:nvPr/>
        </p:nvSpPr>
        <p:spPr>
          <a:xfrm>
            <a:off x="4123113" y="2643195"/>
            <a:ext cx="11388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371417"/>
            <a:r>
              <a:rPr kumimoji="1" lang="en-US" altLang="ja-JP" sz="1600" dirty="0">
                <a:solidFill>
                  <a:prstClr val="black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Exclusion</a:t>
            </a:r>
            <a:endParaRPr kumimoji="1" lang="ja-JP" altLang="en-US" sz="1600" dirty="0">
              <a:solidFill>
                <a:prstClr val="black"/>
              </a:solidFill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7C6BDB9D-ED08-8ADA-9E0B-C173D3F6117D}"/>
              </a:ext>
            </a:extLst>
          </p:cNvPr>
          <p:cNvSpPr/>
          <p:nvPr/>
        </p:nvSpPr>
        <p:spPr>
          <a:xfrm>
            <a:off x="4225636" y="2981749"/>
            <a:ext cx="3945776" cy="7174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defTabSz="1371417"/>
            <a:r>
              <a:rPr kumimoji="1" lang="en-US" altLang="ja-JP" sz="1600" dirty="0">
                <a:solidFill>
                  <a:prstClr val="black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4 patients: OFDI could not pass before RA</a:t>
            </a:r>
          </a:p>
          <a:p>
            <a:pPr defTabSz="1371417"/>
            <a:r>
              <a:rPr lang="en-US" altLang="ja-JP" sz="1600" dirty="0">
                <a:solidFill>
                  <a:prstClr val="black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1</a:t>
            </a:r>
            <a:r>
              <a:rPr kumimoji="1" lang="en-US" altLang="ja-JP" sz="1600" dirty="0">
                <a:solidFill>
                  <a:prstClr val="black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solidFill>
                  <a:schemeClr val="tx1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patient:</a:t>
            </a:r>
            <a:r>
              <a:rPr lang="en-US" altLang="ja-JP" sz="1600" dirty="0">
                <a:solidFill>
                  <a:schemeClr val="tx1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 Poor </a:t>
            </a:r>
            <a:r>
              <a:rPr lang="en-US" altLang="ja-JP" sz="1600" dirty="0">
                <a:solidFill>
                  <a:prstClr val="black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study</a:t>
            </a:r>
            <a:endParaRPr kumimoji="1" lang="en-US" altLang="ja-JP" sz="1600" dirty="0">
              <a:solidFill>
                <a:prstClr val="black"/>
              </a:solidFill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5696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39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濱名 智世</dc:creator>
  <cp:lastModifiedBy>濱名 智世</cp:lastModifiedBy>
  <cp:revision>2</cp:revision>
  <dcterms:created xsi:type="dcterms:W3CDTF">2022-11-06T02:46:46Z</dcterms:created>
  <dcterms:modified xsi:type="dcterms:W3CDTF">2023-03-20T16:13:21Z</dcterms:modified>
</cp:coreProperties>
</file>